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7" r:id="rId2"/>
  </p:sldIdLst>
  <p:sldSz cx="7745413" cy="972026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14" userDrawn="1">
          <p15:clr>
            <a:srgbClr val="A4A3A4"/>
          </p15:clr>
        </p15:guide>
        <p15:guide id="2" pos="3870">
          <p15:clr>
            <a:srgbClr val="A4A3A4"/>
          </p15:clr>
        </p15:guide>
        <p15:guide id="3" orient="horz" pos="1838">
          <p15:clr>
            <a:srgbClr val="A4A3A4"/>
          </p15:clr>
        </p15:guide>
        <p15:guide id="4" pos="3918">
          <p15:clr>
            <a:srgbClr val="A4A3A4"/>
          </p15:clr>
        </p15:guide>
        <p15:guide id="5" orient="horz" pos="385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6"/>
  </p:normalViewPr>
  <p:slideViewPr>
    <p:cSldViewPr snapToObjects="1" showGuides="1">
      <p:cViewPr varScale="1">
        <p:scale>
          <a:sx n="72" d="100"/>
          <a:sy n="72" d="100"/>
        </p:scale>
        <p:origin x="2368" y="208"/>
      </p:cViewPr>
      <p:guideLst>
        <p:guide orient="horz" pos="1214"/>
        <p:guide pos="3870"/>
        <p:guide orient="horz" pos="1838"/>
        <p:guide pos="3918"/>
        <p:guide orient="horz" pos="385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CE90B1-D876-8447-8909-05D91A4A6E68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62163" y="685800"/>
            <a:ext cx="27336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92034F-38EF-7648-A648-A1E9CE2BAC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155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80908" y="3019583"/>
            <a:ext cx="6583601" cy="2083556"/>
          </a:xfrm>
        </p:spPr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61813" y="5508152"/>
            <a:ext cx="5421790" cy="248406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173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644559" y="551270"/>
            <a:ext cx="1441507" cy="11756567"/>
          </a:xfrm>
        </p:spPr>
        <p:txBody>
          <a:bodyPr vert="eaVert"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320038" y="551270"/>
            <a:ext cx="4195432" cy="11756567"/>
          </a:xfrm>
        </p:spPr>
        <p:txBody>
          <a:bodyPr vert="eaVert"/>
          <a:lstStyle/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520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235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1835" y="6246170"/>
            <a:ext cx="6583601" cy="193055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1835" y="4119866"/>
            <a:ext cx="6583601" cy="212630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493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20037" y="3215339"/>
            <a:ext cx="2818470" cy="909249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67597" y="3215339"/>
            <a:ext cx="2818470" cy="909249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339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87273" y="389261"/>
            <a:ext cx="6970871" cy="1620044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87272" y="2175809"/>
            <a:ext cx="3422235" cy="90677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87272" y="3082584"/>
            <a:ext cx="3422235" cy="560040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934564" y="2175809"/>
            <a:ext cx="3423581" cy="90677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934564" y="3082584"/>
            <a:ext cx="3423581" cy="560040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790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483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855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87271" y="387013"/>
            <a:ext cx="2548188" cy="164704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028243" y="387014"/>
            <a:ext cx="4329900" cy="829597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87271" y="2034059"/>
            <a:ext cx="2548188" cy="664893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891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518157" y="6804184"/>
            <a:ext cx="4647248" cy="8032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518157" y="868523"/>
            <a:ext cx="4647248" cy="583215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518157" y="7607457"/>
            <a:ext cx="4647248" cy="11407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975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87273" y="389261"/>
            <a:ext cx="6970871" cy="162004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87273" y="2268062"/>
            <a:ext cx="6970871" cy="64149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87272" y="9009244"/>
            <a:ext cx="1807264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646351" y="9009244"/>
            <a:ext cx="2452715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550880" y="9009244"/>
            <a:ext cx="1807264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23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807777"/>
              </p:ext>
            </p:extLst>
          </p:nvPr>
        </p:nvGraphicFramePr>
        <p:xfrm>
          <a:off x="1215983" y="766932"/>
          <a:ext cx="4669153" cy="952500"/>
        </p:xfrm>
        <a:graphic>
          <a:graphicData uri="http://schemas.openxmlformats.org/drawingml/2006/table">
            <a:tbl>
              <a:tblPr/>
              <a:tblGrid>
                <a:gridCol w="9005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1141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2828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1443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1443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lc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uptak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ac excretio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ac/</a:t>
                      </a:r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(</a:t>
                      </a:r>
                      <a:r>
                        <a:rPr lang="mr-I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Glc</a:t>
                      </a:r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)</a:t>
                      </a:r>
                      <a:r>
                        <a:rPr lang="mr-I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(%)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lc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</a:t>
                      </a:r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(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/2Lac</a:t>
                      </a:r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nit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mo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/cell/h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mo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/cell/h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mo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/cell/h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Quiescent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24±0.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6±0.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2%±2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6±0.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roliferating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71±0.0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66±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%±9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38±0.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value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1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3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2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102095" y="29339"/>
            <a:ext cx="25587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/>
                <a:cs typeface="Arial"/>
              </a:rPr>
              <a:t>Figure </a:t>
            </a:r>
            <a:r>
              <a:rPr lang="en-US" altLang="zh-CN" sz="1400" b="1">
                <a:latin typeface="Arial"/>
                <a:cs typeface="Arial"/>
              </a:rPr>
              <a:t>1-table supplement 1</a:t>
            </a:r>
          </a:p>
        </p:txBody>
      </p:sp>
    </p:spTree>
    <p:extLst>
      <p:ext uri="{BB962C8B-B14F-4D97-AF65-F5344CB8AC3E}">
        <p14:creationId xmlns:p14="http://schemas.microsoft.com/office/powerpoint/2010/main" val="17932054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43</TotalTime>
  <Words>57</Words>
  <Application>Microsoft Macintosh PowerPoint</Application>
  <PresentationFormat>自定义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Company>Washington University in St. Louis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onghui Yao</dc:creator>
  <cp:lastModifiedBy>Yao, Conghui</cp:lastModifiedBy>
  <cp:revision>372</cp:revision>
  <dcterms:created xsi:type="dcterms:W3CDTF">2017-12-29T02:56:55Z</dcterms:created>
  <dcterms:modified xsi:type="dcterms:W3CDTF">2018-12-19T16:50:58Z</dcterms:modified>
</cp:coreProperties>
</file>